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5668963" cy="5121275"/>
  <p:notesSz cx="6858000" cy="9144000"/>
  <p:defaultTextStyle>
    <a:defPPr>
      <a:defRPr lang="en-US"/>
    </a:defPPr>
    <a:lvl1pPr marL="0" algn="l" defTabSz="64773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323867" algn="l" defTabSz="64773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647734" algn="l" defTabSz="64773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971601" algn="l" defTabSz="64773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295469" algn="l" defTabSz="64773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1619336" algn="l" defTabSz="64773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1943204" algn="l" defTabSz="64773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2267071" algn="l" defTabSz="64773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2590938" algn="l" defTabSz="647734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80" d="100"/>
          <a:sy n="80" d="100"/>
        </p:scale>
        <p:origin x="-1062" y="-234"/>
      </p:cViewPr>
      <p:guideLst>
        <p:guide orient="horz" pos="1613"/>
        <p:guide pos="178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peka\Documents\Upeka\Notre%20Dame\PhD\Chapter%205\CGH%20pub\Submission\Additional%20file%20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4!$D$5</c:f>
              <c:strCache>
                <c:ptCount val="1"/>
                <c:pt idx="0">
                  <c:v>Segregating 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cat>
            <c:numRef>
              <c:f>Sheet4!$A$6:$A$26</c:f>
              <c:numCache>
                <c:formatCode>General</c:formatCode>
                <c:ptCount val="21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</c:numCache>
            </c:numRef>
          </c:cat>
          <c:val>
            <c:numRef>
              <c:f>Sheet4!$D$6:$D$27</c:f>
              <c:numCache>
                <c:formatCode>0.0</c:formatCode>
                <c:ptCount val="22"/>
                <c:pt idx="0" formatCode="General">
                  <c:v>0</c:v>
                </c:pt>
                <c:pt idx="1">
                  <c:v>26.666666666666668</c:v>
                </c:pt>
                <c:pt idx="2">
                  <c:v>17.777777777777779</c:v>
                </c:pt>
                <c:pt idx="3">
                  <c:v>8.8888888888888893</c:v>
                </c:pt>
                <c:pt idx="4">
                  <c:v>6.666666666666667</c:v>
                </c:pt>
                <c:pt idx="5">
                  <c:v>15.555555555555587</c:v>
                </c:pt>
                <c:pt idx="6">
                  <c:v>6.666666666666667</c:v>
                </c:pt>
                <c:pt idx="7">
                  <c:v>2.2222222222222232</c:v>
                </c:pt>
                <c:pt idx="8">
                  <c:v>6.666666666666667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2.2222222222222232</c:v>
                </c:pt>
                <c:pt idx="16">
                  <c:v>0</c:v>
                </c:pt>
                <c:pt idx="17">
                  <c:v>2.2222222222222232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4.4444444444444464</c:v>
                </c:pt>
              </c:numCache>
            </c:numRef>
          </c:val>
        </c:ser>
        <c:ser>
          <c:idx val="1"/>
          <c:order val="1"/>
          <c:tx>
            <c:strRef>
              <c:f>Sheet4!$E$5</c:f>
              <c:strCache>
                <c:ptCount val="1"/>
                <c:pt idx="0">
                  <c:v>De novo </c:v>
                </c:pt>
              </c:strCache>
            </c:strRef>
          </c:tx>
          <c:spPr>
            <a:solidFill>
              <a:srgbClr val="C00000"/>
            </a:solidFill>
          </c:spPr>
          <c:invertIfNegative val="0"/>
          <c:cat>
            <c:numRef>
              <c:f>Sheet4!$A$6:$A$26</c:f>
              <c:numCache>
                <c:formatCode>General</c:formatCode>
                <c:ptCount val="21"/>
                <c:pt idx="0">
                  <c:v>1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5</c:v>
                </c:pt>
                <c:pt idx="16">
                  <c:v>80</c:v>
                </c:pt>
                <c:pt idx="17">
                  <c:v>85</c:v>
                </c:pt>
                <c:pt idx="18">
                  <c:v>90</c:v>
                </c:pt>
                <c:pt idx="19">
                  <c:v>95</c:v>
                </c:pt>
                <c:pt idx="20">
                  <c:v>100</c:v>
                </c:pt>
              </c:numCache>
            </c:numRef>
          </c:cat>
          <c:val>
            <c:numRef>
              <c:f>Sheet4!$E$6:$E$27</c:f>
              <c:numCache>
                <c:formatCode>0.0</c:formatCode>
                <c:ptCount val="22"/>
                <c:pt idx="0" formatCode="General">
                  <c:v>4.0322580645161334</c:v>
                </c:pt>
                <c:pt idx="1">
                  <c:v>57.258064516129039</c:v>
                </c:pt>
                <c:pt idx="2">
                  <c:v>15.322580645161334</c:v>
                </c:pt>
                <c:pt idx="3">
                  <c:v>2.4193548387096775</c:v>
                </c:pt>
                <c:pt idx="4">
                  <c:v>5.6451612903225801</c:v>
                </c:pt>
                <c:pt idx="5">
                  <c:v>2.4193548387096775</c:v>
                </c:pt>
                <c:pt idx="6">
                  <c:v>3.2258064516129052</c:v>
                </c:pt>
                <c:pt idx="7">
                  <c:v>0</c:v>
                </c:pt>
                <c:pt idx="8">
                  <c:v>0</c:v>
                </c:pt>
                <c:pt idx="9">
                  <c:v>3.2258064516129052</c:v>
                </c:pt>
                <c:pt idx="10">
                  <c:v>0</c:v>
                </c:pt>
                <c:pt idx="11">
                  <c:v>1.6129032258064515</c:v>
                </c:pt>
                <c:pt idx="12">
                  <c:v>0</c:v>
                </c:pt>
                <c:pt idx="13">
                  <c:v>0</c:v>
                </c:pt>
                <c:pt idx="14">
                  <c:v>1.6129032258064515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.80645161290322664</c:v>
                </c:pt>
                <c:pt idx="21">
                  <c:v>2.41935483870967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183104"/>
        <c:axId val="17186176"/>
      </c:barChart>
      <c:catAx>
        <c:axId val="171831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>
                    <a:latin typeface="Arial" pitchFamily="34" charset="0"/>
                    <a:cs typeface="Arial" pitchFamily="34" charset="0"/>
                  </a:defRPr>
                </a:pPr>
                <a:r>
                  <a:rPr lang="en-US" sz="1200">
                    <a:latin typeface="Arial" pitchFamily="34" charset="0"/>
                    <a:cs typeface="Arial" pitchFamily="34" charset="0"/>
                  </a:rPr>
                  <a:t>CNV size (kb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 rot="-3060000" vert="horz"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7186176"/>
        <c:crosses val="autoZero"/>
        <c:auto val="1"/>
        <c:lblAlgn val="ctr"/>
        <c:lblOffset val="100"/>
        <c:noMultiLvlLbl val="0"/>
      </c:catAx>
      <c:valAx>
        <c:axId val="17186176"/>
        <c:scaling>
          <c:orientation val="minMax"/>
          <c:max val="6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Arial" pitchFamily="34" charset="0"/>
                    <a:cs typeface="Arial" pitchFamily="34" charset="0"/>
                  </a:defRPr>
                </a:pPr>
                <a:r>
                  <a:rPr lang="en-US" sz="1200">
                    <a:latin typeface="Arial" pitchFamily="34" charset="0"/>
                    <a:cs typeface="Arial" pitchFamily="34" charset="0"/>
                  </a:rPr>
                  <a:t>Frequency (%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7183104"/>
        <c:crosses val="autoZero"/>
        <c:crossBetween val="between"/>
      </c:valAx>
    </c:plotArea>
    <c:legend>
      <c:legendPos val="r"/>
      <c:legendEntry>
        <c:idx val="1"/>
        <c:txPr>
          <a:bodyPr/>
          <a:lstStyle/>
          <a:p>
            <a:pPr>
              <a:defRPr i="1">
                <a:latin typeface="Arial" pitchFamily="34" charset="0"/>
                <a:cs typeface="Arial" pitchFamily="34" charset="0"/>
              </a:defRPr>
            </a:pPr>
            <a:endParaRPr lang="en-US"/>
          </a:p>
        </c:txPr>
      </c:legendEntry>
      <c:layout>
        <c:manualLayout>
          <c:xMode val="edge"/>
          <c:yMode val="edge"/>
          <c:x val="0.72827909011373893"/>
          <c:y val="0.11535688247302421"/>
          <c:w val="0.20210411198600176"/>
          <c:h val="0.15799285505978444"/>
        </c:manualLayout>
      </c:layout>
      <c:overlay val="1"/>
      <c:txPr>
        <a:bodyPr/>
        <a:lstStyle/>
        <a:p>
          <a:pPr>
            <a:defRPr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A67788-04D0-4471-A0D7-8587007D9CAA}" type="datetimeFigureOut">
              <a:rPr lang="en-US" smtClean="0"/>
              <a:t>8/10/201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531938" y="685800"/>
            <a:ext cx="3794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95DB58-C317-42DF-8157-053F202D5F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56615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47734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1pPr>
    <a:lvl2pPr marL="323867" algn="l" defTabSz="647734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2pPr>
    <a:lvl3pPr marL="647734" algn="l" defTabSz="647734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3pPr>
    <a:lvl4pPr marL="971601" algn="l" defTabSz="647734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4pPr>
    <a:lvl5pPr marL="1295469" algn="l" defTabSz="647734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5pPr>
    <a:lvl6pPr marL="1619336" algn="l" defTabSz="647734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6pPr>
    <a:lvl7pPr marL="1943204" algn="l" defTabSz="647734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7pPr>
    <a:lvl8pPr marL="2267071" algn="l" defTabSz="647734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8pPr>
    <a:lvl9pPr marL="2590938" algn="l" defTabSz="647734" rtl="0" eaLnBrk="1" latinLnBrk="0" hangingPunct="1">
      <a:defRPr sz="9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531938" y="685800"/>
            <a:ext cx="379412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F95DB58-C317-42DF-8157-053F202D5F4E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25173" y="1590919"/>
            <a:ext cx="4818618" cy="109775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0349" y="2902057"/>
            <a:ext cx="3968275" cy="130877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2386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477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716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2954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6193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9432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2670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5909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0BA9A-8848-4593-9ED0-71F5556D5B65}" type="datetimeFigureOut">
              <a:rPr lang="en-US" smtClean="0"/>
              <a:t>8/10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DB4F-A67B-4B51-B180-5F83E8FDED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0BA9A-8848-4593-9ED0-71F5556D5B65}" type="datetimeFigureOut">
              <a:rPr lang="en-US" smtClean="0"/>
              <a:t>8/10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DB4F-A67B-4B51-B180-5F83E8FDED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110004" y="136335"/>
            <a:ext cx="1275517" cy="2913911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83450" y="136335"/>
            <a:ext cx="3732067" cy="2913911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0BA9A-8848-4593-9ED0-71F5556D5B65}" type="datetimeFigureOut">
              <a:rPr lang="en-US" smtClean="0"/>
              <a:t>8/10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DB4F-A67B-4B51-B180-5F83E8FDED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0BA9A-8848-4593-9ED0-71F5556D5B65}" type="datetimeFigureOut">
              <a:rPr lang="en-US" smtClean="0"/>
              <a:t>8/10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DB4F-A67B-4B51-B180-5F83E8FDED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810" y="3290896"/>
            <a:ext cx="4818618" cy="1017142"/>
          </a:xfrm>
        </p:spPr>
        <p:txBody>
          <a:bodyPr anchor="t"/>
          <a:lstStyle>
            <a:lvl1pPr algn="l">
              <a:defRPr sz="28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7810" y="2170619"/>
            <a:ext cx="4818618" cy="1120281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2386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2pPr>
            <a:lvl3pPr marL="64773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971601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4pPr>
            <a:lvl5pPr marL="1295469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5pPr>
            <a:lvl6pPr marL="1619336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6pPr>
            <a:lvl7pPr marL="1943204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7pPr>
            <a:lvl8pPr marL="2267071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8pPr>
            <a:lvl9pPr marL="2590938" indent="0">
              <a:buNone/>
              <a:defRPr sz="1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0BA9A-8848-4593-9ED0-71F5556D5B65}" type="datetimeFigureOut">
              <a:rPr lang="en-US" smtClean="0"/>
              <a:t>8/10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DB4F-A67B-4B51-B180-5F83E8FDED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83448" y="796646"/>
            <a:ext cx="2503792" cy="2253599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881723" y="796646"/>
            <a:ext cx="2503792" cy="2253599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0BA9A-8848-4593-9ED0-71F5556D5B65}" type="datetimeFigureOut">
              <a:rPr lang="en-US" smtClean="0"/>
              <a:t>8/10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DB4F-A67B-4B51-B180-5F83E8FDED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3453" y="205091"/>
            <a:ext cx="5102067" cy="853546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3450" y="1146364"/>
            <a:ext cx="2504778" cy="4777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23867" indent="0">
              <a:buNone/>
              <a:defRPr sz="1500" b="1"/>
            </a:lvl2pPr>
            <a:lvl3pPr marL="647734" indent="0">
              <a:buNone/>
              <a:defRPr sz="1300" b="1"/>
            </a:lvl3pPr>
            <a:lvl4pPr marL="971601" indent="0">
              <a:buNone/>
              <a:defRPr sz="1200" b="1"/>
            </a:lvl4pPr>
            <a:lvl5pPr marL="1295469" indent="0">
              <a:buNone/>
              <a:defRPr sz="1200" b="1"/>
            </a:lvl5pPr>
            <a:lvl6pPr marL="1619336" indent="0">
              <a:buNone/>
              <a:defRPr sz="1200" b="1"/>
            </a:lvl6pPr>
            <a:lvl7pPr marL="1943204" indent="0">
              <a:buNone/>
              <a:defRPr sz="1200" b="1"/>
            </a:lvl7pPr>
            <a:lvl8pPr marL="2267071" indent="0">
              <a:buNone/>
              <a:defRPr sz="1200" b="1"/>
            </a:lvl8pPr>
            <a:lvl9pPr marL="2590938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83450" y="1624112"/>
            <a:ext cx="2504778" cy="2950662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879763" y="1146364"/>
            <a:ext cx="2505761" cy="4777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23867" indent="0">
              <a:buNone/>
              <a:defRPr sz="1500" b="1"/>
            </a:lvl2pPr>
            <a:lvl3pPr marL="647734" indent="0">
              <a:buNone/>
              <a:defRPr sz="1300" b="1"/>
            </a:lvl3pPr>
            <a:lvl4pPr marL="971601" indent="0">
              <a:buNone/>
              <a:defRPr sz="1200" b="1"/>
            </a:lvl4pPr>
            <a:lvl5pPr marL="1295469" indent="0">
              <a:buNone/>
              <a:defRPr sz="1200" b="1"/>
            </a:lvl5pPr>
            <a:lvl6pPr marL="1619336" indent="0">
              <a:buNone/>
              <a:defRPr sz="1200" b="1"/>
            </a:lvl6pPr>
            <a:lvl7pPr marL="1943204" indent="0">
              <a:buNone/>
              <a:defRPr sz="1200" b="1"/>
            </a:lvl7pPr>
            <a:lvl8pPr marL="2267071" indent="0">
              <a:buNone/>
              <a:defRPr sz="1200" b="1"/>
            </a:lvl8pPr>
            <a:lvl9pPr marL="2590938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879763" y="1624112"/>
            <a:ext cx="2505761" cy="2950662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0BA9A-8848-4593-9ED0-71F5556D5B65}" type="datetimeFigureOut">
              <a:rPr lang="en-US" smtClean="0"/>
              <a:t>8/10/201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DB4F-A67B-4B51-B180-5F83E8FDED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0BA9A-8848-4593-9ED0-71F5556D5B65}" type="datetimeFigureOut">
              <a:rPr lang="en-US" smtClean="0"/>
              <a:t>8/10/201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DB4F-A67B-4B51-B180-5F83E8FDED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0BA9A-8848-4593-9ED0-71F5556D5B65}" type="datetimeFigureOut">
              <a:rPr lang="en-US" smtClean="0"/>
              <a:t>8/10/201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DB4F-A67B-4B51-B180-5F83E8FDED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3449" y="203905"/>
            <a:ext cx="1865050" cy="86777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16409" y="203905"/>
            <a:ext cx="3169109" cy="4370867"/>
          </a:xfrm>
        </p:spPr>
        <p:txBody>
          <a:bodyPr/>
          <a:lstStyle>
            <a:lvl1pPr>
              <a:defRPr sz="22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83449" y="1071680"/>
            <a:ext cx="1865050" cy="3503095"/>
          </a:xfrm>
        </p:spPr>
        <p:txBody>
          <a:bodyPr/>
          <a:lstStyle>
            <a:lvl1pPr marL="0" indent="0">
              <a:buNone/>
              <a:defRPr sz="1000"/>
            </a:lvl1pPr>
            <a:lvl2pPr marL="323867" indent="0">
              <a:buNone/>
              <a:defRPr sz="900"/>
            </a:lvl2pPr>
            <a:lvl3pPr marL="647734" indent="0">
              <a:buNone/>
              <a:defRPr sz="700"/>
            </a:lvl3pPr>
            <a:lvl4pPr marL="971601" indent="0">
              <a:buNone/>
              <a:defRPr sz="700"/>
            </a:lvl4pPr>
            <a:lvl5pPr marL="1295469" indent="0">
              <a:buNone/>
              <a:defRPr sz="700"/>
            </a:lvl5pPr>
            <a:lvl6pPr marL="1619336" indent="0">
              <a:buNone/>
              <a:defRPr sz="700"/>
            </a:lvl6pPr>
            <a:lvl7pPr marL="1943204" indent="0">
              <a:buNone/>
              <a:defRPr sz="700"/>
            </a:lvl7pPr>
            <a:lvl8pPr marL="2267071" indent="0">
              <a:buNone/>
              <a:defRPr sz="700"/>
            </a:lvl8pPr>
            <a:lvl9pPr marL="2590938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0BA9A-8848-4593-9ED0-71F5556D5B65}" type="datetimeFigureOut">
              <a:rPr lang="en-US" smtClean="0"/>
              <a:t>8/10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DB4F-A67B-4B51-B180-5F83E8FDED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1158" y="3584896"/>
            <a:ext cx="3401378" cy="423216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11158" y="457597"/>
            <a:ext cx="3401378" cy="3072765"/>
          </a:xfrm>
        </p:spPr>
        <p:txBody>
          <a:bodyPr/>
          <a:lstStyle>
            <a:lvl1pPr marL="0" indent="0">
              <a:buNone/>
              <a:defRPr sz="2200"/>
            </a:lvl1pPr>
            <a:lvl2pPr marL="323867" indent="0">
              <a:buNone/>
              <a:defRPr sz="2100"/>
            </a:lvl2pPr>
            <a:lvl3pPr marL="647734" indent="0">
              <a:buNone/>
              <a:defRPr sz="1800"/>
            </a:lvl3pPr>
            <a:lvl4pPr marL="971601" indent="0">
              <a:buNone/>
              <a:defRPr sz="1500"/>
            </a:lvl4pPr>
            <a:lvl5pPr marL="1295469" indent="0">
              <a:buNone/>
              <a:defRPr sz="1500"/>
            </a:lvl5pPr>
            <a:lvl6pPr marL="1619336" indent="0">
              <a:buNone/>
              <a:defRPr sz="1500"/>
            </a:lvl6pPr>
            <a:lvl7pPr marL="1943204" indent="0">
              <a:buNone/>
              <a:defRPr sz="1500"/>
            </a:lvl7pPr>
            <a:lvl8pPr marL="2267071" indent="0">
              <a:buNone/>
              <a:defRPr sz="1500"/>
            </a:lvl8pPr>
            <a:lvl9pPr marL="2590938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1158" y="4008112"/>
            <a:ext cx="3401378" cy="601038"/>
          </a:xfrm>
        </p:spPr>
        <p:txBody>
          <a:bodyPr/>
          <a:lstStyle>
            <a:lvl1pPr marL="0" indent="0">
              <a:buNone/>
              <a:defRPr sz="1000"/>
            </a:lvl1pPr>
            <a:lvl2pPr marL="323867" indent="0">
              <a:buNone/>
              <a:defRPr sz="900"/>
            </a:lvl2pPr>
            <a:lvl3pPr marL="647734" indent="0">
              <a:buNone/>
              <a:defRPr sz="700"/>
            </a:lvl3pPr>
            <a:lvl4pPr marL="971601" indent="0">
              <a:buNone/>
              <a:defRPr sz="700"/>
            </a:lvl4pPr>
            <a:lvl5pPr marL="1295469" indent="0">
              <a:buNone/>
              <a:defRPr sz="700"/>
            </a:lvl5pPr>
            <a:lvl6pPr marL="1619336" indent="0">
              <a:buNone/>
              <a:defRPr sz="700"/>
            </a:lvl6pPr>
            <a:lvl7pPr marL="1943204" indent="0">
              <a:buNone/>
              <a:defRPr sz="700"/>
            </a:lvl7pPr>
            <a:lvl8pPr marL="2267071" indent="0">
              <a:buNone/>
              <a:defRPr sz="700"/>
            </a:lvl8pPr>
            <a:lvl9pPr marL="2590938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0BA9A-8848-4593-9ED0-71F5556D5B65}" type="datetimeFigureOut">
              <a:rPr lang="en-US" smtClean="0"/>
              <a:t>8/10/201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F6DB4F-A67B-4B51-B180-5F83E8FDED8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83453" y="205091"/>
            <a:ext cx="5102067" cy="853546"/>
          </a:xfrm>
          <a:prstGeom prst="rect">
            <a:avLst/>
          </a:prstGeom>
        </p:spPr>
        <p:txBody>
          <a:bodyPr vert="horz" lIns="64774" tIns="32387" rIns="64774" bIns="32387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3453" y="1194969"/>
            <a:ext cx="5102067" cy="3379805"/>
          </a:xfrm>
          <a:prstGeom prst="rect">
            <a:avLst/>
          </a:prstGeom>
        </p:spPr>
        <p:txBody>
          <a:bodyPr vert="horz" lIns="64774" tIns="32387" rIns="64774" bIns="32387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83448" y="4746668"/>
            <a:ext cx="1322758" cy="272661"/>
          </a:xfrm>
          <a:prstGeom prst="rect">
            <a:avLst/>
          </a:prstGeom>
        </p:spPr>
        <p:txBody>
          <a:bodyPr vert="horz" lIns="64774" tIns="32387" rIns="64774" bIns="32387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40BA9A-8848-4593-9ED0-71F5556D5B65}" type="datetimeFigureOut">
              <a:rPr lang="en-US" smtClean="0"/>
              <a:t>8/10/201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36896" y="4746668"/>
            <a:ext cx="1795172" cy="272661"/>
          </a:xfrm>
          <a:prstGeom prst="rect">
            <a:avLst/>
          </a:prstGeom>
        </p:spPr>
        <p:txBody>
          <a:bodyPr vert="horz" lIns="64774" tIns="32387" rIns="64774" bIns="32387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062757" y="4746668"/>
            <a:ext cx="1322758" cy="272661"/>
          </a:xfrm>
          <a:prstGeom prst="rect">
            <a:avLst/>
          </a:prstGeom>
        </p:spPr>
        <p:txBody>
          <a:bodyPr vert="horz" lIns="64774" tIns="32387" rIns="64774" bIns="32387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F6DB4F-A67B-4B51-B180-5F83E8FDED81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47734" rtl="0" eaLnBrk="1" latinLnBrk="0" hangingPunct="1">
        <a:spcBef>
          <a:spcPct val="0"/>
        </a:spcBef>
        <a:buNone/>
        <a:defRPr sz="3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2901" indent="-242901" algn="l" defTabSz="647734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526284" indent="-202417" algn="l" defTabSz="647734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09668" indent="-161934" algn="l" defTabSz="647734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133536" indent="-161934" algn="l" defTabSz="647734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457403" indent="-161934" algn="l" defTabSz="647734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781270" indent="-161934" algn="l" defTabSz="647734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105137" indent="-161934" algn="l" defTabSz="647734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429004" indent="-161934" algn="l" defTabSz="647734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752871" indent="-161934" algn="l" defTabSz="647734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7734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1pPr>
      <a:lvl2pPr marL="323867" algn="l" defTabSz="647734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2pPr>
      <a:lvl3pPr marL="647734" algn="l" defTabSz="647734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3pPr>
      <a:lvl4pPr marL="971601" algn="l" defTabSz="647734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295469" algn="l" defTabSz="647734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619336" algn="l" defTabSz="647734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6pPr>
      <a:lvl7pPr marL="1943204" algn="l" defTabSz="647734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7pPr>
      <a:lvl8pPr marL="2267071" algn="l" defTabSz="647734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8pPr>
      <a:lvl9pPr marL="2590938" algn="l" defTabSz="647734" rtl="0" eaLnBrk="1" latinLnBrk="0" hangingPunct="1">
        <a:defRPr sz="1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7420113"/>
              </p:ext>
            </p:extLst>
          </p:nvPr>
        </p:nvGraphicFramePr>
        <p:xfrm>
          <a:off x="87390" y="127700"/>
          <a:ext cx="5486400" cy="32918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Rectangle 8"/>
          <p:cNvSpPr/>
          <p:nvPr/>
        </p:nvSpPr>
        <p:spPr>
          <a:xfrm>
            <a:off x="87390" y="69787"/>
            <a:ext cx="5486400" cy="327660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145878" y="3129662"/>
            <a:ext cx="5454868" cy="20389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0" tIns="152352" rIns="0" bIns="38088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2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dditional file 6  – Size distribution of segregating and </a:t>
            </a:r>
            <a:r>
              <a:rPr kumimoji="0" lang="en-GB" sz="12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de novo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CNVs.</a:t>
            </a:r>
            <a:endParaRPr kumimoji="0" lang="en-GB" sz="11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Times New Roman" pitchFamily="18" charset="0"/>
              <a:cs typeface="Arial" pitchFamily="34" charset="0"/>
            </a:endParaRPr>
          </a:p>
          <a:p>
            <a:pPr lvl="0" eaLnBrk="0" fontAlgn="base" hangingPunct="0">
              <a:lnSpc>
                <a:spcPct val="200000"/>
              </a:lnSpc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he size distribution of the CNVs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was assessed as a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percentage of total CNVs in each category. </a:t>
            </a:r>
            <a:r>
              <a:rPr kumimoji="0" lang="en-US" altLang="zh-CN" sz="1200" b="0" i="1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 novo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CNVs were predominantly &lt;10 kb (76%), while segregating CNVs were &gt;10 kb (55%). In both segregating and </a:t>
            </a:r>
            <a:r>
              <a:rPr kumimoji="0" lang="en-US" altLang="zh-CN" sz="1200" b="0" i="1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 novo 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NVs, a small percentage of CNVs were </a:t>
            </a:r>
            <a:r>
              <a:rPr lang="en-US" altLang="zh-CN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&gt; 100 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kb (segregating = 4%, </a:t>
            </a:r>
            <a:r>
              <a:rPr kumimoji="0" lang="en-US" altLang="zh-CN" sz="1200" b="0" i="1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e novo 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= 2%).</a:t>
            </a:r>
            <a:endParaRPr kumimoji="0" lang="en-US" altLang="zh-CN" sz="1800" b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87</Words>
  <Application>Microsoft Office PowerPoint</Application>
  <PresentationFormat>Custom</PresentationFormat>
  <Paragraphs>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Grizli777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peka</dc:creator>
  <cp:lastModifiedBy>Upeka</cp:lastModifiedBy>
  <cp:revision>4</cp:revision>
  <dcterms:created xsi:type="dcterms:W3CDTF">2011-07-04T05:17:59Z</dcterms:created>
  <dcterms:modified xsi:type="dcterms:W3CDTF">2011-08-10T11:13:18Z</dcterms:modified>
</cp:coreProperties>
</file>